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6D429-2958-4018-BD1A-4D35C38304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46C25-3B34-427F-BBC7-2EA4FB1066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F76A4-BFD3-4D50-A925-096A97FCA3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94EC6-0270-4A54-A1C2-A9420618A1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85A89-4B8E-43F6-9748-B5E38DB23D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87461-EF33-4E14-92CB-26D764CDE0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50D3BD-A651-44FD-BA9C-30AD2BF30C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DEDDA-526D-4F48-A534-A55AE3384B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34976-239E-4596-8520-2DA17E37F5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588FF-1734-402F-865C-8FC119F68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B2061-713C-447E-B196-8658C6504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CDA3C-4DC3-421B-A9AA-5F86E21149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A8F5E16-2AA4-4FBE-BC01-DF32E2C7B992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"/>
          <p:cNvPicPr/>
          <p:nvPr/>
        </p:nvPicPr>
        <p:blipFill>
          <a:blip r:embed="rId1"/>
          <a:srcRect l="89452" t="0" r="1515" b="0"/>
          <a:stretch/>
        </p:blipFill>
        <p:spPr>
          <a:xfrm>
            <a:off x="5872320" y="1138320"/>
            <a:ext cx="488880" cy="540072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649"/>
          <p:cNvSpPr/>
          <p:nvPr/>
        </p:nvSpPr>
        <p:spPr>
          <a:xfrm>
            <a:off x="471600" y="1947960"/>
            <a:ext cx="268200" cy="11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图片 4" descr=""/>
          <p:cNvPicPr/>
          <p:nvPr/>
        </p:nvPicPr>
        <p:blipFill>
          <a:blip r:embed="rId2"/>
          <a:srcRect l="3662" t="0" r="12519" b="3752"/>
          <a:stretch/>
        </p:blipFill>
        <p:spPr>
          <a:xfrm>
            <a:off x="825480" y="998640"/>
            <a:ext cx="5030640" cy="5775120"/>
          </a:xfrm>
          <a:prstGeom prst="rect">
            <a:avLst/>
          </a:prstGeom>
          <a:ln w="0">
            <a:noFill/>
          </a:ln>
        </p:spPr>
      </p:pic>
      <p:sp>
        <p:nvSpPr>
          <p:cNvPr id="44" name="直接连接符 6"/>
          <p:cNvSpPr/>
          <p:nvPr/>
        </p:nvSpPr>
        <p:spPr>
          <a:xfrm>
            <a:off x="728640" y="1170000"/>
            <a:ext cx="0" cy="16747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直接连接符 8"/>
          <p:cNvSpPr/>
          <p:nvPr/>
        </p:nvSpPr>
        <p:spPr>
          <a:xfrm>
            <a:off x="725400" y="117648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直接连接符 53"/>
          <p:cNvSpPr/>
          <p:nvPr/>
        </p:nvSpPr>
        <p:spPr>
          <a:xfrm>
            <a:off x="725400" y="283860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直接连接符 54"/>
          <p:cNvSpPr/>
          <p:nvPr/>
        </p:nvSpPr>
        <p:spPr>
          <a:xfrm>
            <a:off x="725400" y="301932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直接连接符 55"/>
          <p:cNvSpPr/>
          <p:nvPr/>
        </p:nvSpPr>
        <p:spPr>
          <a:xfrm>
            <a:off x="725400" y="467532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直接连接符 56"/>
          <p:cNvSpPr/>
          <p:nvPr/>
        </p:nvSpPr>
        <p:spPr>
          <a:xfrm>
            <a:off x="730080" y="3013200"/>
            <a:ext cx="0" cy="16700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直接连接符 57"/>
          <p:cNvSpPr/>
          <p:nvPr/>
        </p:nvSpPr>
        <p:spPr>
          <a:xfrm>
            <a:off x="725400" y="486396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直接连接符 58"/>
          <p:cNvSpPr/>
          <p:nvPr/>
        </p:nvSpPr>
        <p:spPr>
          <a:xfrm>
            <a:off x="725400" y="6518160"/>
            <a:ext cx="65556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接连接符 59"/>
          <p:cNvSpPr/>
          <p:nvPr/>
        </p:nvSpPr>
        <p:spPr>
          <a:xfrm>
            <a:off x="728640" y="4856040"/>
            <a:ext cx="0" cy="16671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649"/>
          <p:cNvSpPr/>
          <p:nvPr/>
        </p:nvSpPr>
        <p:spPr>
          <a:xfrm>
            <a:off x="473040" y="3781440"/>
            <a:ext cx="268200" cy="1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649"/>
          <p:cNvSpPr/>
          <p:nvPr/>
        </p:nvSpPr>
        <p:spPr>
          <a:xfrm>
            <a:off x="473040" y="5626080"/>
            <a:ext cx="268200" cy="1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矩形 5"/>
          <p:cNvSpPr/>
          <p:nvPr/>
        </p:nvSpPr>
        <p:spPr>
          <a:xfrm>
            <a:off x="463680" y="7189920"/>
            <a:ext cx="5945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7: Figure S3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 GO analysis of DEGs between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-overexpression line OX707-#21 and wild-type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649"/>
          <p:cNvSpPr/>
          <p:nvPr/>
        </p:nvSpPr>
        <p:spPr>
          <a:xfrm>
            <a:off x="3033720" y="6784920"/>
            <a:ext cx="2773440" cy="1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GeneRati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01T05:41:34Z</dcterms:created>
  <dc:creator>csb</dc:creator>
  <dc:description/>
  <dc:language>en-US</dc:language>
  <cp:lastModifiedBy>Admin</cp:lastModifiedBy>
  <cp:lastPrinted>2020-12-03T05:55:54Z</cp:lastPrinted>
  <dcterms:modified xsi:type="dcterms:W3CDTF">2020-12-03T07:53:01Z</dcterms:modified>
  <cp:revision>151</cp:revision>
  <dc:subject/>
  <dc:title>PowerPoint 演示文稿</dc:title>
</cp:coreProperties>
</file>